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40538" cy="54006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1" userDrawn="1">
          <p15:clr>
            <a:srgbClr val="A4A3A4"/>
          </p15:clr>
        </p15:guide>
        <p15:guide id="2" pos="215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94" d="100"/>
          <a:sy n="94" d="100"/>
        </p:scale>
        <p:origin x="1398" y="72"/>
      </p:cViewPr>
      <p:guideLst>
        <p:guide orient="horz" pos="1701"/>
        <p:guide pos="21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883861"/>
            <a:ext cx="5814457" cy="1880235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2836605"/>
            <a:ext cx="5130404" cy="130391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7656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805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287536"/>
            <a:ext cx="1474991" cy="4576822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287536"/>
            <a:ext cx="4339466" cy="4576822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579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925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1346420"/>
            <a:ext cx="5899964" cy="2246530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3614203"/>
            <a:ext cx="5899964" cy="1181397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075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1437680"/>
            <a:ext cx="2907229" cy="342667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1437680"/>
            <a:ext cx="2907229" cy="342667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533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287537"/>
            <a:ext cx="5899964" cy="1043881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1323916"/>
            <a:ext cx="2893868" cy="64883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1972747"/>
            <a:ext cx="2893868" cy="290161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1323916"/>
            <a:ext cx="2908120" cy="64883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1972747"/>
            <a:ext cx="2908120" cy="290161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5945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21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322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360045"/>
            <a:ext cx="2206252" cy="126015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777598"/>
            <a:ext cx="3463022" cy="3837980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1620202"/>
            <a:ext cx="2206252" cy="3001626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5862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360045"/>
            <a:ext cx="2206252" cy="126015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777598"/>
            <a:ext cx="3463022" cy="3837980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1620202"/>
            <a:ext cx="2206252" cy="3001626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2012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287537"/>
            <a:ext cx="5899964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1437680"/>
            <a:ext cx="5899964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5005627"/>
            <a:ext cx="1539121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BE20D-CBC3-4618-B27F-BDF2E2B94EC8}" type="datetimeFigureOut">
              <a:rPr kumimoji="1" lang="ja-JP" altLang="en-US" smtClean="0"/>
              <a:t>2017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5005627"/>
            <a:ext cx="2308682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5005627"/>
            <a:ext cx="1539121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19F995-3B0B-41D5-A862-12FDA869B5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4222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kumimoji="1"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kumimoji="1"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kumimoji="1"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35071" y="776352"/>
            <a:ext cx="2988000" cy="1440000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itial patient selection </a:t>
            </a:r>
            <a:r>
              <a:rPr kumimoji="0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riteria</a:t>
            </a:r>
            <a:r>
              <a:rPr kumimoji="0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0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312)</a:t>
            </a:r>
            <a:endParaRPr kumimoji="0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 defTabSz="9144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reast cancer patients</a:t>
            </a:r>
          </a:p>
          <a:p>
            <a:pPr marL="171450" indent="-171450" defTabSz="9144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isease recurred after curative surgery</a:t>
            </a:r>
          </a:p>
          <a:p>
            <a:pPr marL="171450" indent="-171450" defTabSz="9144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tarted</a:t>
            </a:r>
            <a:r>
              <a:rPr kumimoji="0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capecitabine</a:t>
            </a: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treatment </a:t>
            </a:r>
            <a:r>
              <a:rPr kumimoji="0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s </a:t>
            </a: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alliative </a:t>
            </a:r>
            <a:r>
              <a:rPr kumimoji="0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hemotherapy</a:t>
            </a:r>
            <a:endParaRPr kumimoji="0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 defTabSz="914400" eaLnBrk="0" fontAlgn="base" hangingPunct="0">
              <a:spcBef>
                <a:spcPct val="0"/>
              </a:spcBef>
              <a:spcAft>
                <a:spcPct val="0"/>
              </a:spcAft>
              <a:buFont typeface="Arial" pitchFamily="34" charset="0"/>
              <a:buChar char="•"/>
            </a:pP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emotherapy received between 2008-2016 </a:t>
            </a:r>
            <a:endParaRPr kumimoji="0" lang="en-US" altLang="ja-JP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AutoShape 3"/>
          <p:cNvCxnSpPr>
            <a:cxnSpLocks noChangeShapeType="1"/>
          </p:cNvCxnSpPr>
          <p:nvPr/>
        </p:nvCxnSpPr>
        <p:spPr bwMode="auto">
          <a:xfrm>
            <a:off x="3027099" y="2228521"/>
            <a:ext cx="0" cy="1368000"/>
          </a:xfrm>
          <a:prstGeom prst="straightConnector1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6" name="Rectangle 2"/>
          <p:cNvSpPr>
            <a:spLocks noChangeArrowheads="1"/>
          </p:cNvSpPr>
          <p:nvPr/>
        </p:nvSpPr>
        <p:spPr bwMode="auto">
          <a:xfrm>
            <a:off x="1535071" y="3621921"/>
            <a:ext cx="2988000" cy="720000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cluded in analysis </a:t>
            </a:r>
            <a:r>
              <a:rPr kumimoji="0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0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288)</a:t>
            </a:r>
            <a:endParaRPr kumimoji="0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luoropyrimidine (FP) group </a:t>
            </a:r>
            <a:r>
              <a:rPr kumimoji="0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0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105</a:t>
            </a: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171450" indent="-17145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on-FP </a:t>
            </a:r>
            <a:r>
              <a:rPr kumimoji="0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group </a:t>
            </a:r>
            <a:r>
              <a:rPr kumimoji="0" lang="en-US" altLang="ja-JP" sz="120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en-US" altLang="ja-JP" sz="1200" i="1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0" lang="en-US" altLang="ja-JP" sz="1200" smtClean="0">
                <a:latin typeface="Arial" panose="020B0604020202020204" pitchFamily="34" charset="0"/>
                <a:cs typeface="Arial" panose="020B0604020202020204" pitchFamily="34" charset="0"/>
              </a:rPr>
              <a:t>=183</a:t>
            </a: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7" name="AutoShape 4"/>
          <p:cNvCxnSpPr>
            <a:cxnSpLocks noChangeShapeType="1"/>
          </p:cNvCxnSpPr>
          <p:nvPr/>
        </p:nvCxnSpPr>
        <p:spPr bwMode="auto">
          <a:xfrm>
            <a:off x="3036521" y="2912520"/>
            <a:ext cx="432000" cy="2"/>
          </a:xfrm>
          <a:prstGeom prst="straightConnector1">
            <a:avLst/>
          </a:prstGeom>
          <a:noFill/>
          <a:ln w="12700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</p:cxnSp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3478694" y="2523283"/>
            <a:ext cx="2772000" cy="792000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ctr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Excluded for the </a:t>
            </a:r>
            <a:r>
              <a:rPr kumimoji="0" lang="en-US" altLang="ja-JP" sz="12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ollowing </a:t>
            </a:r>
            <a:r>
              <a:rPr kumimoji="0" lang="en-US" altLang="ja-JP" sz="12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reasons:        </a:t>
            </a:r>
            <a:endParaRPr kumimoji="0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kumimoji="0"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or use of ≥2 FPs </a:t>
            </a:r>
            <a:r>
              <a:rPr kumimoji="0" lang="en-US" altLang="ja-JP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0" lang="en-US" altLang="ja-JP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12</a:t>
            </a:r>
            <a:r>
              <a:rPr kumimoji="0"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171450" indent="-17145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kumimoji="0"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perioperative use of FPs </a:t>
            </a:r>
            <a:r>
              <a:rPr kumimoji="0" lang="en-US" altLang="ja-JP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0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0" lang="en-US" altLang="ja-JP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8</a:t>
            </a:r>
            <a:r>
              <a:rPr kumimoji="0"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171450" indent="-17145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kumimoji="0" lang="en-US" altLang="ja-JP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ufficient baseline (</a:t>
            </a:r>
            <a:r>
              <a:rPr kumimoji="0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kumimoji="0" lang="en-US" altLang="ja-JP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4</a:t>
            </a:r>
            <a:r>
              <a:rPr kumimoji="0"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391920" y="4510059"/>
            <a:ext cx="4858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1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low diagram of the patient selection proces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1133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82</Words>
  <Application>Microsoft Office PowerPoint</Application>
  <PresentationFormat>ユーザー設定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ＭＳ 明朝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飯泉桜</dc:creator>
  <cp:lastModifiedBy>飯泉桜</cp:lastModifiedBy>
  <cp:revision>6</cp:revision>
  <dcterms:created xsi:type="dcterms:W3CDTF">2017-10-23T02:50:08Z</dcterms:created>
  <dcterms:modified xsi:type="dcterms:W3CDTF">2017-11-07T22:52:15Z</dcterms:modified>
</cp:coreProperties>
</file>